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סגנון ביניים 2 - הדגשה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500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ya Engler" userId="1252e1b0b8bb23a8" providerId="LiveId" clId="{FA74E907-1F4F-4010-B836-60241FDB84CB}"/>
    <pc:docChg chg="modSld">
      <pc:chgData name="Maya Engler" userId="1252e1b0b8bb23a8" providerId="LiveId" clId="{FA74E907-1F4F-4010-B836-60241FDB84CB}" dt="2025-06-17T07:38:02.690" v="15" actId="1076"/>
      <pc:docMkLst>
        <pc:docMk/>
      </pc:docMkLst>
      <pc:sldChg chg="modSp mod">
        <pc:chgData name="Maya Engler" userId="1252e1b0b8bb23a8" providerId="LiveId" clId="{FA74E907-1F4F-4010-B836-60241FDB84CB}" dt="2025-06-17T07:38:02.690" v="15" actId="1076"/>
        <pc:sldMkLst>
          <pc:docMk/>
          <pc:sldMk cId="691892706" sldId="256"/>
        </pc:sldMkLst>
        <pc:graphicFrameChg chg="mod modGraphic">
          <ac:chgData name="Maya Engler" userId="1252e1b0b8bb23a8" providerId="LiveId" clId="{FA74E907-1F4F-4010-B836-60241FDB84CB}" dt="2025-06-17T07:37:58.776" v="14" actId="1076"/>
          <ac:graphicFrameMkLst>
            <pc:docMk/>
            <pc:sldMk cId="691892706" sldId="256"/>
            <ac:graphicFrameMk id="4" creationId="{1F40D2AB-A44B-DC85-22E2-5D209840A129}"/>
          </ac:graphicFrameMkLst>
        </pc:graphicFrameChg>
        <pc:graphicFrameChg chg="mod">
          <ac:chgData name="Maya Engler" userId="1252e1b0b8bb23a8" providerId="LiveId" clId="{FA74E907-1F4F-4010-B836-60241FDB84CB}" dt="2025-06-17T07:38:02.690" v="15" actId="1076"/>
          <ac:graphicFrameMkLst>
            <pc:docMk/>
            <pc:sldMk cId="691892706" sldId="256"/>
            <ac:graphicFrameMk id="5" creationId="{77183155-2681-929D-B064-3B07C1172087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שקופית כותרת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F9A965D0-DAFC-6AFB-D507-3EED0CE618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כותרת משנה 2">
            <a:extLst>
              <a:ext uri="{FF2B5EF4-FFF2-40B4-BE49-F238E27FC236}">
                <a16:creationId xmlns:a16="http://schemas.microsoft.com/office/drawing/2014/main" id="{0B486373-F1E3-5B5A-8AA9-41551C8181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he-IL"/>
              <a:t>לחץ כדי לערוך סגנון כותרת משנה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4DB85B43-7FF4-D7A4-6735-CD8110B71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9F27A4A6-AF4C-C6EB-D245-EFB3B7301B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04248EEF-E723-CCA9-3615-3104393C38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42205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כותרת וטקסט אנכ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F3E0CE28-A5F8-F4A5-D806-50DDF0F07A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D706D334-E47E-BA33-AA28-13E6EBB811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5D65288C-1216-672F-B979-D03414645F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C250F0BF-1FB4-3312-4691-72D4B5FBB7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CD9145FF-78A5-8884-22BA-9B9E45294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69158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כותרת אנכית וטקס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אנכית 1">
            <a:extLst>
              <a:ext uri="{FF2B5EF4-FFF2-40B4-BE49-F238E27FC236}">
                <a16:creationId xmlns:a16="http://schemas.microsoft.com/office/drawing/2014/main" id="{E0EC46F0-485E-B4C2-2CBB-05900810A1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טקסט אנכי 2">
            <a:extLst>
              <a:ext uri="{FF2B5EF4-FFF2-40B4-BE49-F238E27FC236}">
                <a16:creationId xmlns:a16="http://schemas.microsoft.com/office/drawing/2014/main" id="{96350C85-6372-306B-8455-79C0CD3BEE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B41274EA-DA82-8E39-A670-604E22312B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9B802E5A-4A15-E684-7D1F-1943495AD6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16E60F9D-B9DC-FAF6-9AFB-0E8F4F0BF0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27560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כותרת ותוכ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83DCEB0E-BE28-ACB1-6476-44761DFC45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2662092F-E549-DE22-D147-DAD99008CF1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54DB552B-7E31-DD7D-05B8-34CC14251E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BD880223-7784-001B-528A-15507DF0E7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79D00D75-0751-0CFC-39F6-EF91028731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081293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כותרת מקטע עליונ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A434FF8F-0E37-0C48-1C36-BED36EA4F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FFF60371-DECB-029F-181D-A4F4D5019F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63DA3D29-A394-72CB-F62C-60E7693BC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21B8BD40-5F1A-D5DD-D5DF-CBDB480E64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724D42E1-C5F7-716E-43D1-9783A34E5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6518234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שני תכנים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568204B1-6944-648A-C2D3-5AC8BA040F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2611727A-C1F7-DA03-81D5-699D7B53E2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97E91820-452B-C0E5-63EE-31D63B6419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35866276-29B1-D6A1-AB29-A85341452F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10FEFEE9-4728-7100-204F-31769C8FC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B15D3862-EC64-4F35-8428-D58A8789C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85539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השוואה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E756F170-4205-A53F-B5AD-02E49D1BB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A0526C1C-AE8C-81E5-956F-BC43E0CCE8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4" name="מציין מיקום תוכן 3">
            <a:extLst>
              <a:ext uri="{FF2B5EF4-FFF2-40B4-BE49-F238E27FC236}">
                <a16:creationId xmlns:a16="http://schemas.microsoft.com/office/drawing/2014/main" id="{1A37B79F-B1D1-374F-E595-293AE4EFF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5" name="מציין מיקום טקסט 4">
            <a:extLst>
              <a:ext uri="{FF2B5EF4-FFF2-40B4-BE49-F238E27FC236}">
                <a16:creationId xmlns:a16="http://schemas.microsoft.com/office/drawing/2014/main" id="{F5E54FC7-6592-3A61-6048-88EAC55D2A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6" name="מציין מיקום תוכן 5">
            <a:extLst>
              <a:ext uri="{FF2B5EF4-FFF2-40B4-BE49-F238E27FC236}">
                <a16:creationId xmlns:a16="http://schemas.microsoft.com/office/drawing/2014/main" id="{F1A4E3DF-5236-34F6-C31F-CA24CBDCC35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7" name="מציין מיקום של תאריך 6">
            <a:extLst>
              <a:ext uri="{FF2B5EF4-FFF2-40B4-BE49-F238E27FC236}">
                <a16:creationId xmlns:a16="http://schemas.microsoft.com/office/drawing/2014/main" id="{31DEA3D6-4CD4-56BD-332E-C93A9CB221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8" name="מציין מיקום של כותרת תחתונה 7">
            <a:extLst>
              <a:ext uri="{FF2B5EF4-FFF2-40B4-BE49-F238E27FC236}">
                <a16:creationId xmlns:a16="http://schemas.microsoft.com/office/drawing/2014/main" id="{1E15BB75-FAD0-F0FB-0E84-71DC02C1B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מציין מיקום של מספר שקופית 8">
            <a:extLst>
              <a:ext uri="{FF2B5EF4-FFF2-40B4-BE49-F238E27FC236}">
                <a16:creationId xmlns:a16="http://schemas.microsoft.com/office/drawing/2014/main" id="{8B46F37A-4CB8-AC96-840A-4B478753BF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7042367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כותרת בלבד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4CEC989E-6D92-161D-D2D8-A52DF2E44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אריך 2">
            <a:extLst>
              <a:ext uri="{FF2B5EF4-FFF2-40B4-BE49-F238E27FC236}">
                <a16:creationId xmlns:a16="http://schemas.microsoft.com/office/drawing/2014/main" id="{E3A9951E-5B0E-DD22-67F2-DBB38697C2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4" name="מציין מיקום של כותרת תחתונה 3">
            <a:extLst>
              <a:ext uri="{FF2B5EF4-FFF2-40B4-BE49-F238E27FC236}">
                <a16:creationId xmlns:a16="http://schemas.microsoft.com/office/drawing/2014/main" id="{0B3E5FC6-0F90-E062-B4EF-8CF4AF130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מציין מיקום של מספר שקופית 4">
            <a:extLst>
              <a:ext uri="{FF2B5EF4-FFF2-40B4-BE49-F238E27FC236}">
                <a16:creationId xmlns:a16="http://schemas.microsoft.com/office/drawing/2014/main" id="{05A39E5E-9546-D1FB-4190-5B61C4718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820315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ריק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תאריך 1">
            <a:extLst>
              <a:ext uri="{FF2B5EF4-FFF2-40B4-BE49-F238E27FC236}">
                <a16:creationId xmlns:a16="http://schemas.microsoft.com/office/drawing/2014/main" id="{674E0CBB-3F48-EDF2-B524-3F2B5F4DA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3" name="מציין מיקום של כותרת תחתונה 2">
            <a:extLst>
              <a:ext uri="{FF2B5EF4-FFF2-40B4-BE49-F238E27FC236}">
                <a16:creationId xmlns:a16="http://schemas.microsoft.com/office/drawing/2014/main" id="{6FD6BA3E-812D-05BF-CA56-2A501CBCEC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מציין מיקום של מספר שקופית 3">
            <a:extLst>
              <a:ext uri="{FF2B5EF4-FFF2-40B4-BE49-F238E27FC236}">
                <a16:creationId xmlns:a16="http://schemas.microsoft.com/office/drawing/2014/main" id="{276B5793-AF48-7FF7-76A2-6B8C543696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479754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תוכן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E5F58F37-3AAF-252A-4841-70AE21D315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תוכן 2">
            <a:extLst>
              <a:ext uri="{FF2B5EF4-FFF2-40B4-BE49-F238E27FC236}">
                <a16:creationId xmlns:a16="http://schemas.microsoft.com/office/drawing/2014/main" id="{203A8B56-CD95-A77E-DE9E-3A83A2AD8D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E820F537-2E1E-06BF-0E7F-15187696A1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58265A61-386D-3A20-FA60-960EA23B59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247F6826-E5CD-36FB-8442-18016CA57B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0EAAE73C-D66C-3CFB-062C-B9AF52774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765757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תמונה עם כיתוב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כותרת 1">
            <a:extLst>
              <a:ext uri="{FF2B5EF4-FFF2-40B4-BE49-F238E27FC236}">
                <a16:creationId xmlns:a16="http://schemas.microsoft.com/office/drawing/2014/main" id="{20B945FD-7FD7-1302-31FA-351A4D2C70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של תמונה 2">
            <a:extLst>
              <a:ext uri="{FF2B5EF4-FFF2-40B4-BE49-F238E27FC236}">
                <a16:creationId xmlns:a16="http://schemas.microsoft.com/office/drawing/2014/main" id="{DB78DBA2-4438-AE20-BDDE-360BB49FC2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מציין מיקום טקסט 3">
            <a:extLst>
              <a:ext uri="{FF2B5EF4-FFF2-40B4-BE49-F238E27FC236}">
                <a16:creationId xmlns:a16="http://schemas.microsoft.com/office/drawing/2014/main" id="{71AB29B6-96E1-6454-8511-CA7C26DD1F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he-IL"/>
              <a:t>לחץ כדי לערוך סגנונות טקסט של תבנית בסיס</a:t>
            </a:r>
          </a:p>
        </p:txBody>
      </p:sp>
      <p:sp>
        <p:nvSpPr>
          <p:cNvPr id="5" name="מציין מיקום של תאריך 4">
            <a:extLst>
              <a:ext uri="{FF2B5EF4-FFF2-40B4-BE49-F238E27FC236}">
                <a16:creationId xmlns:a16="http://schemas.microsoft.com/office/drawing/2014/main" id="{276CFB30-417F-6DF6-E39B-30291F494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6" name="מציין מיקום של כותרת תחתונה 5">
            <a:extLst>
              <a:ext uri="{FF2B5EF4-FFF2-40B4-BE49-F238E27FC236}">
                <a16:creationId xmlns:a16="http://schemas.microsoft.com/office/drawing/2014/main" id="{E3DB865C-72E3-3D9B-FC23-9276533463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מציין מיקום של מספר שקופית 6">
            <a:extLst>
              <a:ext uri="{FF2B5EF4-FFF2-40B4-BE49-F238E27FC236}">
                <a16:creationId xmlns:a16="http://schemas.microsoft.com/office/drawing/2014/main" id="{B08CC58D-1DE6-26D8-5383-E0C5A31BFE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502906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מציין מיקום של כותרת 1">
            <a:extLst>
              <a:ext uri="{FF2B5EF4-FFF2-40B4-BE49-F238E27FC236}">
                <a16:creationId xmlns:a16="http://schemas.microsoft.com/office/drawing/2014/main" id="{0523E2A6-99A8-411E-AF40-C640B68662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he-IL"/>
              <a:t>לחץ כדי לערוך סגנון כותרת של תבנית בסיס</a:t>
            </a:r>
          </a:p>
        </p:txBody>
      </p:sp>
      <p:sp>
        <p:nvSpPr>
          <p:cNvPr id="3" name="מציין מיקום טקסט 2">
            <a:extLst>
              <a:ext uri="{FF2B5EF4-FFF2-40B4-BE49-F238E27FC236}">
                <a16:creationId xmlns:a16="http://schemas.microsoft.com/office/drawing/2014/main" id="{04EAAE7E-8D2B-E638-5155-7B5B231035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he-IL"/>
              <a:t>לחץ כדי לערוך סגנונות טקסט של תבנית בסיס</a:t>
            </a:r>
          </a:p>
          <a:p>
            <a:pPr lvl="1"/>
            <a:r>
              <a:rPr lang="he-IL"/>
              <a:t>רמה שנייה</a:t>
            </a:r>
          </a:p>
          <a:p>
            <a:pPr lvl="2"/>
            <a:r>
              <a:rPr lang="he-IL"/>
              <a:t>רמה שלישית</a:t>
            </a:r>
          </a:p>
          <a:p>
            <a:pPr lvl="3"/>
            <a:r>
              <a:rPr lang="he-IL"/>
              <a:t>רמה רביעית</a:t>
            </a:r>
          </a:p>
          <a:p>
            <a:pPr lvl="4"/>
            <a:r>
              <a:rPr lang="he-IL"/>
              <a:t>רמה חמישית</a:t>
            </a:r>
          </a:p>
        </p:txBody>
      </p:sp>
      <p:sp>
        <p:nvSpPr>
          <p:cNvPr id="4" name="מציין מיקום של תאריך 3">
            <a:extLst>
              <a:ext uri="{FF2B5EF4-FFF2-40B4-BE49-F238E27FC236}">
                <a16:creationId xmlns:a16="http://schemas.microsoft.com/office/drawing/2014/main" id="{4A66554A-897D-ABB9-83DE-0F14E6A91B4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A02ECD-1EF5-47C5-BDA2-810C1F36C054}" type="datetimeFigureOut">
              <a:rPr lang="he-IL" smtClean="0"/>
              <a:t>כ"א/סיון/תשפ"ה</a:t>
            </a:fld>
            <a:endParaRPr lang="he-IL"/>
          </a:p>
        </p:txBody>
      </p:sp>
      <p:sp>
        <p:nvSpPr>
          <p:cNvPr id="5" name="מציין מיקום של כותרת תחתונה 4">
            <a:extLst>
              <a:ext uri="{FF2B5EF4-FFF2-40B4-BE49-F238E27FC236}">
                <a16:creationId xmlns:a16="http://schemas.microsoft.com/office/drawing/2014/main" id="{074441FF-09C4-25A3-5B3A-3C98BBAC3B9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מציין מיקום של מספר שקופית 5">
            <a:extLst>
              <a:ext uri="{FF2B5EF4-FFF2-40B4-BE49-F238E27FC236}">
                <a16:creationId xmlns:a16="http://schemas.microsoft.com/office/drawing/2014/main" id="{1F9F2D51-AE0B-55DB-92BD-C3B99F4CF48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BE4FE0-D618-4492-B39F-53D2FB09E7CB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9955685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טבלה 3">
            <a:extLst>
              <a:ext uri="{FF2B5EF4-FFF2-40B4-BE49-F238E27FC236}">
                <a16:creationId xmlns:a16="http://schemas.microsoft.com/office/drawing/2014/main" id="{1F40D2AB-A44B-DC85-22E2-5D209840A12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73207013"/>
              </p:ext>
            </p:extLst>
          </p:nvPr>
        </p:nvGraphicFramePr>
        <p:xfrm>
          <a:off x="519684" y="525018"/>
          <a:ext cx="5701284" cy="3619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018284">
                  <a:extLst>
                    <a:ext uri="{9D8B030D-6E8A-4147-A177-3AD203B41FA5}">
                      <a16:colId xmlns:a16="http://schemas.microsoft.com/office/drawing/2014/main" val="4112155427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1985967344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053381105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419735759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172528901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342842951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042632394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830252287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803051671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632695433"/>
                    </a:ext>
                  </a:extLst>
                </a:gridCol>
                <a:gridCol w="368300">
                  <a:extLst>
                    <a:ext uri="{9D8B030D-6E8A-4147-A177-3AD203B41FA5}">
                      <a16:colId xmlns:a16="http://schemas.microsoft.com/office/drawing/2014/main" val="2261523936"/>
                    </a:ext>
                  </a:extLst>
                </a:gridCol>
              </a:tblGrid>
              <a:tr h="17780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Author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2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3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4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5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6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7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8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9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he-IL" sz="1100" u="none" strike="noStrike">
                          <a:effectLst/>
                        </a:rPr>
                        <a:t>10</a:t>
                      </a:r>
                      <a:endParaRPr lang="he-IL" sz="11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extLst>
                  <a:ext uri="{0D108BD9-81ED-4DB2-BD59-A6C34878D82A}">
                    <a16:rowId xmlns:a16="http://schemas.microsoft.com/office/drawing/2014/main" val="693341789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1100" u="none" strike="noStrike" dirty="0">
                          <a:effectLst/>
                        </a:rPr>
                        <a:t> Casanova-</a:t>
                      </a:r>
                      <a:r>
                        <a:rPr lang="en-US" sz="1100" u="none" strike="noStrike" dirty="0" err="1">
                          <a:effectLst/>
                        </a:rPr>
                        <a:t>Esquembre</a:t>
                      </a:r>
                      <a:r>
                        <a:rPr lang="en-US" sz="1100" u="none" strike="noStrike" dirty="0">
                          <a:effectLst/>
                        </a:rPr>
                        <a:t> et al. [48]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ptos" panose="020B00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he-IL" sz="1100" u="none" strike="noStrike" dirty="0">
                          <a:effectLst/>
                        </a:rPr>
                        <a:t> </a:t>
                      </a:r>
                      <a:endParaRPr lang="he-IL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00518933"/>
                  </a:ext>
                </a:extLst>
              </a:tr>
            </a:tbl>
          </a:graphicData>
        </a:graphic>
      </p:graphicFrame>
      <p:graphicFrame>
        <p:nvGraphicFramePr>
          <p:cNvPr id="5" name="טבלה 4">
            <a:extLst>
              <a:ext uri="{FF2B5EF4-FFF2-40B4-BE49-F238E27FC236}">
                <a16:creationId xmlns:a16="http://schemas.microsoft.com/office/drawing/2014/main" id="{77183155-2681-929D-B064-3B07C11720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5409280"/>
              </p:ext>
            </p:extLst>
          </p:nvPr>
        </p:nvGraphicFramePr>
        <p:xfrm>
          <a:off x="6393180" y="525018"/>
          <a:ext cx="1320800" cy="55245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400">
                  <a:extLst>
                    <a:ext uri="{9D8B030D-6E8A-4147-A177-3AD203B41FA5}">
                      <a16:colId xmlns:a16="http://schemas.microsoft.com/office/drawing/2014/main" val="3025770046"/>
                    </a:ext>
                  </a:extLst>
                </a:gridCol>
                <a:gridCol w="660400">
                  <a:extLst>
                    <a:ext uri="{9D8B030D-6E8A-4147-A177-3AD203B41FA5}">
                      <a16:colId xmlns:a16="http://schemas.microsoft.com/office/drawing/2014/main" val="2354388209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Yes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92D05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720482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No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FF0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9847590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Unclear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 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b"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7458592"/>
                  </a:ext>
                </a:extLst>
              </a:tr>
            </a:tbl>
          </a:graphicData>
        </a:graphic>
      </p:graphicFrame>
      <p:graphicFrame>
        <p:nvGraphicFramePr>
          <p:cNvPr id="7" name="טבלה 6">
            <a:extLst>
              <a:ext uri="{FF2B5EF4-FFF2-40B4-BE49-F238E27FC236}">
                <a16:creationId xmlns:a16="http://schemas.microsoft.com/office/drawing/2014/main" id="{3EA080B4-272F-0FE2-F018-0C9438C6BD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07300914"/>
              </p:ext>
            </p:extLst>
          </p:nvPr>
        </p:nvGraphicFramePr>
        <p:xfrm>
          <a:off x="519684" y="1224395"/>
          <a:ext cx="7569200" cy="18415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60400">
                  <a:extLst>
                    <a:ext uri="{9D8B030D-6E8A-4147-A177-3AD203B41FA5}">
                      <a16:colId xmlns:a16="http://schemas.microsoft.com/office/drawing/2014/main" val="3408244059"/>
                    </a:ext>
                  </a:extLst>
                </a:gridCol>
                <a:gridCol w="6908800">
                  <a:extLst>
                    <a:ext uri="{9D8B030D-6E8A-4147-A177-3AD203B41FA5}">
                      <a16:colId xmlns:a16="http://schemas.microsoft.com/office/drawing/2014/main" val="3722179967"/>
                    </a:ext>
                  </a:extLst>
                </a:gridCol>
              </a:tblGrid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the groups comparable other than the presence of disease in cases or the absence of disease in control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52175489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2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cases and controls matched appropriately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95194548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3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the same criteria used for identification of cases and control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683356015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4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as exposure measured in a standard, valid and reliable way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20860867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5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as exposure measured in the same way for cases and control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785100320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6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confounding factors identified? 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84901424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7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strategies to deal with confounding factors stated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8036881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8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ere outcomes assessed in a standard, valid and reliable way for cases and controls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287222221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9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>
                          <a:effectLst/>
                        </a:rPr>
                        <a:t>Was the exposure period of interest long enough to be meaningful?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456413458"/>
                  </a:ext>
                </a:extLst>
              </a:tr>
              <a:tr h="1841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u="none" strike="noStrike">
                          <a:effectLst/>
                        </a:rPr>
                        <a:t>10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6350" marR="6350" marT="6350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NZ" sz="1100" u="none" strike="noStrike" dirty="0">
                          <a:effectLst/>
                        </a:rPr>
                        <a:t>Was appropriate statistical analysis used?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581770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91892706"/>
      </p:ext>
    </p:extLst>
  </p:cSld>
  <p:clrMapOvr>
    <a:masterClrMapping/>
  </p:clrMapOvr>
</p:sld>
</file>

<file path=ppt/theme/theme1.xml><?xml version="1.0" encoding="utf-8"?>
<a:theme xmlns:a="http://schemas.openxmlformats.org/drawingml/2006/main" name="ערכת נושא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57</Words>
  <Application>Microsoft Office PowerPoint</Application>
  <PresentationFormat>מסך רחב</PresentationFormat>
  <Paragraphs>48</Paragraphs>
  <Slides>1</Slides>
  <Notes>0</Notes>
  <HiddenSlides>0</HiddenSlides>
  <MMClips>0</MMClips>
  <ScaleCrop>false</ScaleCrop>
  <HeadingPairs>
    <vt:vector size="6" baseType="variant">
      <vt:variant>
        <vt:lpstr>גופנים בשימוש</vt:lpstr>
      </vt:variant>
      <vt:variant>
        <vt:i4>4</vt:i4>
      </vt:variant>
      <vt:variant>
        <vt:lpstr>ערכת נושא</vt:lpstr>
      </vt:variant>
      <vt:variant>
        <vt:i4>1</vt:i4>
      </vt:variant>
      <vt:variant>
        <vt:lpstr>כותרות שקופיות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ערכת נושא Office</vt:lpstr>
      <vt:lpstr>מצגת של PowerPoint‏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ya Engler</dc:creator>
  <cp:lastModifiedBy>Maya Engler</cp:lastModifiedBy>
  <cp:revision>1</cp:revision>
  <dcterms:created xsi:type="dcterms:W3CDTF">2025-06-09T11:27:40Z</dcterms:created>
  <dcterms:modified xsi:type="dcterms:W3CDTF">2025-06-17T07:38:05Z</dcterms:modified>
</cp:coreProperties>
</file>